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1"/>
  </p:notesMasterIdLst>
  <p:sldIdLst>
    <p:sldId id="257" r:id="rId2"/>
    <p:sldId id="280" r:id="rId3"/>
    <p:sldId id="276" r:id="rId4"/>
    <p:sldId id="281" r:id="rId5"/>
    <p:sldId id="258" r:id="rId6"/>
    <p:sldId id="282" r:id="rId7"/>
    <p:sldId id="259" r:id="rId8"/>
    <p:sldId id="283" r:id="rId9"/>
    <p:sldId id="260" r:id="rId10"/>
    <p:sldId id="284" r:id="rId11"/>
    <p:sldId id="261" r:id="rId12"/>
    <p:sldId id="275" r:id="rId13"/>
    <p:sldId id="286" r:id="rId14"/>
    <p:sldId id="264" r:id="rId15"/>
    <p:sldId id="285" r:id="rId16"/>
    <p:sldId id="265" r:id="rId17"/>
    <p:sldId id="287" r:id="rId18"/>
    <p:sldId id="266" r:id="rId19"/>
    <p:sldId id="288" r:id="rId20"/>
    <p:sldId id="267" r:id="rId21"/>
    <p:sldId id="289" r:id="rId22"/>
    <p:sldId id="268" r:id="rId23"/>
    <p:sldId id="290" r:id="rId24"/>
    <p:sldId id="269" r:id="rId25"/>
    <p:sldId id="291" r:id="rId26"/>
    <p:sldId id="270" r:id="rId27"/>
    <p:sldId id="292" r:id="rId28"/>
    <p:sldId id="271" r:id="rId29"/>
    <p:sldId id="293" r:id="rId3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496" autoAdjust="0"/>
    <p:restoredTop sz="94660"/>
  </p:normalViewPr>
  <p:slideViewPr>
    <p:cSldViewPr>
      <p:cViewPr varScale="1">
        <p:scale>
          <a:sx n="126" d="100"/>
          <a:sy n="126" d="100"/>
        </p:scale>
        <p:origin x="-119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65716E-1AD0-4BED-8207-56547B75536D}" type="datetimeFigureOut">
              <a:rPr lang="en-US" smtClean="0"/>
              <a:t>10/15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78A03D-312A-4A97-8275-C04C08C5B7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618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9193F-6103-44CE-A9F8-5ECAD4274276}" type="datetimeFigureOut">
              <a:rPr lang="en-US" smtClean="0"/>
              <a:t>10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F0AB2-D1F8-49C8-B43F-9185B7EE03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425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9193F-6103-44CE-A9F8-5ECAD4274276}" type="datetimeFigureOut">
              <a:rPr lang="en-US" smtClean="0"/>
              <a:t>10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F0AB2-D1F8-49C8-B43F-9185B7EE03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6972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9193F-6103-44CE-A9F8-5ECAD4274276}" type="datetimeFigureOut">
              <a:rPr lang="en-US" smtClean="0"/>
              <a:t>10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F0AB2-D1F8-49C8-B43F-9185B7EE03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379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9193F-6103-44CE-A9F8-5ECAD4274276}" type="datetimeFigureOut">
              <a:rPr lang="en-US" smtClean="0"/>
              <a:t>10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F0AB2-D1F8-49C8-B43F-9185B7EE03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0807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9193F-6103-44CE-A9F8-5ECAD4274276}" type="datetimeFigureOut">
              <a:rPr lang="en-US" smtClean="0"/>
              <a:t>10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F0AB2-D1F8-49C8-B43F-9185B7EE03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993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9193F-6103-44CE-A9F8-5ECAD4274276}" type="datetimeFigureOut">
              <a:rPr lang="en-US" smtClean="0"/>
              <a:t>10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F0AB2-D1F8-49C8-B43F-9185B7EE03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963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9193F-6103-44CE-A9F8-5ECAD4274276}" type="datetimeFigureOut">
              <a:rPr lang="en-US" smtClean="0"/>
              <a:t>10/1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F0AB2-D1F8-49C8-B43F-9185B7EE03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89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9193F-6103-44CE-A9F8-5ECAD4274276}" type="datetimeFigureOut">
              <a:rPr lang="en-US" smtClean="0"/>
              <a:t>10/1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F0AB2-D1F8-49C8-B43F-9185B7EE03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228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9193F-6103-44CE-A9F8-5ECAD4274276}" type="datetimeFigureOut">
              <a:rPr lang="en-US" smtClean="0"/>
              <a:t>10/1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F0AB2-D1F8-49C8-B43F-9185B7EE03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202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9193F-6103-44CE-A9F8-5ECAD4274276}" type="datetimeFigureOut">
              <a:rPr lang="en-US" smtClean="0"/>
              <a:t>10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F0AB2-D1F8-49C8-B43F-9185B7EE03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728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9193F-6103-44CE-A9F8-5ECAD4274276}" type="datetimeFigureOut">
              <a:rPr lang="en-US" smtClean="0"/>
              <a:t>10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F0AB2-D1F8-49C8-B43F-9185B7EE03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504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9193F-6103-44CE-A9F8-5ECAD4274276}" type="datetimeFigureOut">
              <a:rPr lang="en-US" smtClean="0"/>
              <a:t>10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6F0AB2-D1F8-49C8-B43F-9185B7EE03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406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24125" y="0"/>
            <a:ext cx="7315200" cy="6035040"/>
            <a:chOff x="-24125" y="0"/>
            <a:chExt cx="7315200" cy="6035040"/>
          </a:xfrm>
        </p:grpSpPr>
        <p:pic>
          <p:nvPicPr>
            <p:cNvPr id="7170" name="Picture 2" descr="C:\Users\michael\AppData\Local\Temp\scp30360\nfs\users\nfs_m\ms29\work\DemGraphs\HeatMapBantu4.png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24125" y="0"/>
              <a:ext cx="7315200" cy="60350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5400000">
              <a:off x="5802274" y="1458874"/>
              <a:ext cx="23070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Lucida Sans" pitchFamily="34" charset="0"/>
                  <a:cs typeface="Aharoni" pitchFamily="2" charset="-79"/>
                </a:rPr>
                <a:t>Length of Expansion in Years</a:t>
              </a:r>
              <a:endParaRPr lang="en-US" sz="1100" b="1" dirty="0">
                <a:latin typeface="Lucida Sans" pitchFamily="34" charset="0"/>
                <a:cs typeface="Aharoni" pitchFamily="2" charset="-79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381000" y="617220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6506658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57200"/>
            <a:ext cx="77724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/>
              <a:t>5</a:t>
            </a:r>
            <a:r>
              <a:rPr lang="en-US" b="1" dirty="0" smtClean="0"/>
              <a:t>. </a:t>
            </a:r>
            <a:r>
              <a:rPr lang="en-US" b="1" dirty="0"/>
              <a:t>Fit between model and observed </a:t>
            </a:r>
            <a:r>
              <a:rPr lang="en-US" b="1" dirty="0" smtClean="0"/>
              <a:t>data – E1b1a</a:t>
            </a:r>
            <a:r>
              <a:rPr lang="en-US" dirty="0" smtClean="0"/>
              <a:t>. </a:t>
            </a:r>
            <a:r>
              <a:rPr lang="en-US" dirty="0"/>
              <a:t>The color of each of the smallest rectangular units indicates the value of AND measuring the fit between the model and the observed tree: red = good fit, yellow and green = intermediate fit, blue = poor fit. Each is based on 1,000 simulations. These small units are assembled into sets with differing values of </a:t>
            </a:r>
            <a:r>
              <a:rPr lang="en-US" dirty="0" err="1"/>
              <a:t>StartN</a:t>
            </a:r>
            <a:r>
              <a:rPr lang="en-US" dirty="0"/>
              <a:t> and </a:t>
            </a:r>
            <a:r>
              <a:rPr lang="en-US" dirty="0" err="1"/>
              <a:t>EndN</a:t>
            </a:r>
            <a:r>
              <a:rPr lang="en-US" dirty="0"/>
              <a:t> to form the grid of intermediate-sized rectangles separated by grey/white borders. This grid shows differing Times when expansion ended and Length of expansion. The </a:t>
            </a:r>
            <a:r>
              <a:rPr lang="en-US" dirty="0" smtClean="0"/>
              <a:t>units with a TMRCA &gt; 20,000 years ago are marked with black squar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5736104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5240" y="0"/>
            <a:ext cx="7315200" cy="6035040"/>
            <a:chOff x="15240" y="0"/>
            <a:chExt cx="7315200" cy="6035040"/>
          </a:xfrm>
        </p:grpSpPr>
        <p:pic>
          <p:nvPicPr>
            <p:cNvPr id="11266" name="Picture 2" descr="C:\Users\michael\AppData\Local\Temp\scp30813\nfs\users\nfs_m\ms29\work\DemGraphs\HeatMapBantu3.png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240" y="0"/>
              <a:ext cx="7315200" cy="60350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5400000">
              <a:off x="5911484" y="1403716"/>
              <a:ext cx="23070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Lucida Sans" pitchFamily="34" charset="0"/>
                  <a:cs typeface="Aharoni" pitchFamily="2" charset="-79"/>
                </a:rPr>
                <a:t>Length of Expansion in Years</a:t>
              </a:r>
              <a:endParaRPr lang="en-US" sz="1100" b="1" dirty="0">
                <a:latin typeface="Lucida Sans" pitchFamily="34" charset="0"/>
                <a:cs typeface="Aharoni" pitchFamily="2" charset="-79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2474477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57200"/>
            <a:ext cx="77724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/>
              <a:t>6</a:t>
            </a:r>
            <a:r>
              <a:rPr lang="en-US" b="1" dirty="0" smtClean="0"/>
              <a:t>. </a:t>
            </a:r>
            <a:r>
              <a:rPr lang="en-US" b="1" dirty="0"/>
              <a:t>Fit between model and observed </a:t>
            </a:r>
            <a:r>
              <a:rPr lang="en-US" b="1" dirty="0" smtClean="0"/>
              <a:t>data – E1b1a</a:t>
            </a:r>
            <a:r>
              <a:rPr lang="en-US" dirty="0" smtClean="0"/>
              <a:t>. </a:t>
            </a:r>
            <a:r>
              <a:rPr lang="en-US" dirty="0"/>
              <a:t>The color of each of the smallest rectangular units indicates the value of AND measuring the fit between the model and the observed tree: red = good fit, yellow and green = intermediate fit, blue = poor fit. Each is based on 1,000 simulations. These small units are assembled into sets with differing values of </a:t>
            </a:r>
            <a:r>
              <a:rPr lang="en-US" dirty="0" err="1"/>
              <a:t>StartN</a:t>
            </a:r>
            <a:r>
              <a:rPr lang="en-US" dirty="0"/>
              <a:t> and </a:t>
            </a:r>
            <a:r>
              <a:rPr lang="en-US" dirty="0" err="1"/>
              <a:t>EndN</a:t>
            </a:r>
            <a:r>
              <a:rPr lang="en-US" dirty="0"/>
              <a:t> to form the grid of intermediate-sized rectangles separated by grey/white borders. This grid shows differing Times when expansion ended and Length of expansion. The </a:t>
            </a:r>
            <a:r>
              <a:rPr lang="en-US" dirty="0" smtClean="0"/>
              <a:t>units with a TMRCA &gt; 20,000 years ago are marked with black squar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9595578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05122592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0"/>
            <a:ext cx="7315200" cy="6035040"/>
            <a:chOff x="0" y="0"/>
            <a:chExt cx="7315200" cy="6035040"/>
          </a:xfrm>
        </p:grpSpPr>
        <p:pic>
          <p:nvPicPr>
            <p:cNvPr id="4099" name="Picture 3" descr="C:\Users\michael\AppData\Local\Temp\scp45317\nfs\users\nfs_m\ms29\work\DemGraphs\HeatMapR1b1.png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7315200" cy="60350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5400000">
              <a:off x="5878826" y="1327516"/>
              <a:ext cx="23070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Lucida Sans" pitchFamily="34" charset="0"/>
                  <a:cs typeface="Aharoni" pitchFamily="2" charset="-79"/>
                </a:rPr>
                <a:t>Length of Expansion in Years</a:t>
              </a:r>
              <a:endParaRPr lang="en-US" sz="1100" b="1" dirty="0">
                <a:latin typeface="Lucida Sans" pitchFamily="34" charset="0"/>
                <a:cs typeface="Aharoni" pitchFamily="2" charset="-79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2530905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57200"/>
            <a:ext cx="77724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/>
              <a:t>1</a:t>
            </a:r>
            <a:r>
              <a:rPr lang="en-US" b="1" dirty="0" smtClean="0"/>
              <a:t>. </a:t>
            </a:r>
            <a:r>
              <a:rPr lang="en-US" b="1" dirty="0"/>
              <a:t>Fit between model and observed </a:t>
            </a:r>
            <a:r>
              <a:rPr lang="en-US" b="1" dirty="0" smtClean="0"/>
              <a:t>data – R1b</a:t>
            </a:r>
            <a:r>
              <a:rPr lang="en-US" dirty="0" smtClean="0"/>
              <a:t>. </a:t>
            </a:r>
            <a:r>
              <a:rPr lang="en-US" dirty="0"/>
              <a:t>The color of each of the smallest rectangular units indicates the value of AND measuring the fit between the model and the observed tree: red = good fit, yellow and green = intermediate fit, blue = poor fit. Each is based on 1,000 simulations. These small units are assembled into sets with differing values of </a:t>
            </a:r>
            <a:r>
              <a:rPr lang="en-US" dirty="0" err="1"/>
              <a:t>StartN</a:t>
            </a:r>
            <a:r>
              <a:rPr lang="en-US" dirty="0"/>
              <a:t> and </a:t>
            </a:r>
            <a:r>
              <a:rPr lang="en-US" dirty="0" err="1"/>
              <a:t>EndN</a:t>
            </a:r>
            <a:r>
              <a:rPr lang="en-US" dirty="0"/>
              <a:t> to form the grid of intermediate-sized rectangles separated by grey/white borders. This grid shows differing Times when expansion ended and Length of expansion. The </a:t>
            </a:r>
            <a:r>
              <a:rPr lang="en-US" dirty="0" smtClean="0"/>
              <a:t>units with a TMRCA &gt; 15,000 years ago are marked with black squar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685029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0"/>
            <a:ext cx="7315200" cy="6035040"/>
            <a:chOff x="0" y="0"/>
            <a:chExt cx="7315200" cy="6035040"/>
          </a:xfrm>
        </p:grpSpPr>
        <p:pic>
          <p:nvPicPr>
            <p:cNvPr id="5123" name="Picture 3" descr="C:\Users\michael\AppData\Local\Temp\scp45272\nfs\users\nfs_m\ms29\work\DemGraphs\HeatMapR1b2.png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7315200" cy="60350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5400000">
              <a:off x="5856702" y="1458874"/>
              <a:ext cx="23070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Lucida Sans" pitchFamily="34" charset="0"/>
                  <a:cs typeface="Aharoni" pitchFamily="2" charset="-79"/>
                </a:rPr>
                <a:t>Length of Expansion in Years</a:t>
              </a:r>
              <a:endParaRPr lang="en-US" sz="1100" b="1" dirty="0">
                <a:latin typeface="Lucida Sans" pitchFamily="34" charset="0"/>
                <a:cs typeface="Aharoni" pitchFamily="2" charset="-79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6529246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57200"/>
            <a:ext cx="77724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/>
              <a:t>2</a:t>
            </a:r>
            <a:r>
              <a:rPr lang="en-US" b="1" dirty="0" smtClean="0"/>
              <a:t>. </a:t>
            </a:r>
            <a:r>
              <a:rPr lang="en-US" b="1" dirty="0"/>
              <a:t>Fit between model and observed </a:t>
            </a:r>
            <a:r>
              <a:rPr lang="en-US" b="1" dirty="0" smtClean="0"/>
              <a:t>data – R1b</a:t>
            </a:r>
            <a:r>
              <a:rPr lang="en-US" dirty="0" smtClean="0"/>
              <a:t>. </a:t>
            </a:r>
            <a:r>
              <a:rPr lang="en-US" dirty="0"/>
              <a:t>The color of each of the smallest rectangular units indicates the value of AND measuring the fit between the model and the observed tree: red = good fit, yellow and green = intermediate fit, blue = poor fit. Each is based on 1,000 simulations. These small units are assembled into sets with differing values of </a:t>
            </a:r>
            <a:r>
              <a:rPr lang="en-US" dirty="0" err="1"/>
              <a:t>StartN</a:t>
            </a:r>
            <a:r>
              <a:rPr lang="en-US" dirty="0"/>
              <a:t> and </a:t>
            </a:r>
            <a:r>
              <a:rPr lang="en-US" dirty="0" err="1"/>
              <a:t>EndN</a:t>
            </a:r>
            <a:r>
              <a:rPr lang="en-US" dirty="0"/>
              <a:t> to form the grid of intermediate-sized rectangles separated by grey/white borders. This grid shows differing Times when expansion ended and Length of expansion. The </a:t>
            </a:r>
            <a:r>
              <a:rPr lang="en-US" dirty="0" smtClean="0"/>
              <a:t>units with a TMRCA &gt; 15,000 years ago are marked with black squar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032889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0"/>
            <a:ext cx="7315200" cy="6035040"/>
            <a:chOff x="0" y="0"/>
            <a:chExt cx="7315200" cy="6035040"/>
          </a:xfrm>
        </p:grpSpPr>
        <p:pic>
          <p:nvPicPr>
            <p:cNvPr id="6147" name="Picture 3" descr="C:\Users\michael\AppData\Local\Temp\scp45470\nfs\users\nfs_m\ms29\work\DemGraphs\HeatMapR1b3.png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7315200" cy="60350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5400000">
              <a:off x="5881004" y="1447988"/>
              <a:ext cx="23070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Lucida Sans" pitchFamily="34" charset="0"/>
                  <a:cs typeface="Aharoni" pitchFamily="2" charset="-79"/>
                </a:rPr>
                <a:t>Length of Expansion in Years</a:t>
              </a:r>
              <a:endParaRPr lang="en-US" sz="1100" b="1" dirty="0">
                <a:latin typeface="Lucida Sans" pitchFamily="34" charset="0"/>
                <a:cs typeface="Aharoni" pitchFamily="2" charset="-79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977116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57200"/>
            <a:ext cx="77724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/>
              <a:t>3</a:t>
            </a:r>
            <a:r>
              <a:rPr lang="en-US" b="1" dirty="0" smtClean="0"/>
              <a:t>. </a:t>
            </a:r>
            <a:r>
              <a:rPr lang="en-US" b="1" dirty="0"/>
              <a:t>Fit between model and observed </a:t>
            </a:r>
            <a:r>
              <a:rPr lang="en-US" b="1" dirty="0" smtClean="0"/>
              <a:t>data – R1b</a:t>
            </a:r>
            <a:r>
              <a:rPr lang="en-US" dirty="0" smtClean="0"/>
              <a:t>. </a:t>
            </a:r>
            <a:r>
              <a:rPr lang="en-US" dirty="0"/>
              <a:t>The color of each of the smallest rectangular units indicates the value of AND measuring the fit between the model and the observed tree: red = good fit, yellow and green = intermediate fit, blue = poor fit. Each is based on 1,000 simulations. These small units are assembled into sets with differing values of </a:t>
            </a:r>
            <a:r>
              <a:rPr lang="en-US" dirty="0" err="1"/>
              <a:t>StartN</a:t>
            </a:r>
            <a:r>
              <a:rPr lang="en-US" dirty="0"/>
              <a:t> and </a:t>
            </a:r>
            <a:r>
              <a:rPr lang="en-US" dirty="0" err="1"/>
              <a:t>EndN</a:t>
            </a:r>
            <a:r>
              <a:rPr lang="en-US" dirty="0"/>
              <a:t> to form the grid of intermediate-sized rectangles separated by grey/white borders. This grid shows differing Times when expansion ended and Length of expansion. The </a:t>
            </a:r>
            <a:r>
              <a:rPr lang="en-US" dirty="0" smtClean="0"/>
              <a:t>units with a TMRCA &gt; 15,000 years ago are marked with black squar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2053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57200"/>
            <a:ext cx="77724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/>
              <a:t>1</a:t>
            </a:r>
            <a:r>
              <a:rPr lang="en-US" b="1" dirty="0" smtClean="0"/>
              <a:t>. </a:t>
            </a:r>
            <a:r>
              <a:rPr lang="en-US" b="1" dirty="0"/>
              <a:t>Fit between model and observed </a:t>
            </a:r>
            <a:r>
              <a:rPr lang="en-US" b="1" dirty="0" smtClean="0"/>
              <a:t>data – E1b1a</a:t>
            </a:r>
            <a:r>
              <a:rPr lang="en-US" dirty="0" smtClean="0"/>
              <a:t>. </a:t>
            </a:r>
            <a:r>
              <a:rPr lang="en-US" dirty="0"/>
              <a:t>The color of each of the smallest rectangular units indicates the value of AND measuring the fit between the model and the observed tree: red = good fit, yellow and green = intermediate fit, blue = poor fit. Each is based on 1,000 simulations. These small units are assembled into sets with differing values of </a:t>
            </a:r>
            <a:r>
              <a:rPr lang="en-US" dirty="0" err="1"/>
              <a:t>StartN</a:t>
            </a:r>
            <a:r>
              <a:rPr lang="en-US" dirty="0"/>
              <a:t> and </a:t>
            </a:r>
            <a:r>
              <a:rPr lang="en-US" dirty="0" err="1"/>
              <a:t>EndN</a:t>
            </a:r>
            <a:r>
              <a:rPr lang="en-US" dirty="0"/>
              <a:t> to form the grid of intermediate-sized rectangles separated by grey/white borders. This grid shows differing Times when expansion ended and Length of expansion. The </a:t>
            </a:r>
            <a:r>
              <a:rPr lang="en-US" dirty="0" smtClean="0"/>
              <a:t>units with a TMRCA &gt; 20,000 years ago are marked with black squar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218552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0"/>
            <a:ext cx="7315200" cy="6035040"/>
            <a:chOff x="0" y="0"/>
            <a:chExt cx="7315200" cy="6035040"/>
          </a:xfrm>
        </p:grpSpPr>
        <p:pic>
          <p:nvPicPr>
            <p:cNvPr id="3075" name="Picture 3" descr="C:\Users\michael\AppData\Local\Temp\scp45837\nfs\users\nfs_m\ms29\work\DemGraphs\HeatMapR1b4.png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7315200" cy="60350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5400000">
              <a:off x="5835284" y="1458874"/>
              <a:ext cx="23070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Lucida Sans" pitchFamily="34" charset="0"/>
                  <a:cs typeface="Aharoni" pitchFamily="2" charset="-79"/>
                </a:rPr>
                <a:t>Length of Expansion in Years</a:t>
              </a:r>
              <a:endParaRPr lang="en-US" sz="1100" b="1" dirty="0">
                <a:latin typeface="Lucida Sans" pitchFamily="34" charset="0"/>
                <a:cs typeface="Aharoni" pitchFamily="2" charset="-79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6753303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57200"/>
            <a:ext cx="77724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/>
              <a:t>4</a:t>
            </a:r>
            <a:r>
              <a:rPr lang="en-US" b="1" dirty="0" smtClean="0"/>
              <a:t>. </a:t>
            </a:r>
            <a:r>
              <a:rPr lang="en-US" b="1" dirty="0"/>
              <a:t>Fit between model and observed </a:t>
            </a:r>
            <a:r>
              <a:rPr lang="en-US" b="1" dirty="0" smtClean="0"/>
              <a:t>data – R1b</a:t>
            </a:r>
            <a:r>
              <a:rPr lang="en-US" dirty="0" smtClean="0"/>
              <a:t>. </a:t>
            </a:r>
            <a:r>
              <a:rPr lang="en-US" dirty="0"/>
              <a:t>The color of each of the smallest rectangular units indicates the value of AND measuring the fit between the model and the observed tree: red = good fit, yellow and green = intermediate fit, blue = poor fit. Each is based on 1,000 simulations. These small units are assembled into sets with differing values of </a:t>
            </a:r>
            <a:r>
              <a:rPr lang="en-US" dirty="0" err="1"/>
              <a:t>StartN</a:t>
            </a:r>
            <a:r>
              <a:rPr lang="en-US" dirty="0"/>
              <a:t> and </a:t>
            </a:r>
            <a:r>
              <a:rPr lang="en-US" dirty="0" err="1"/>
              <a:t>EndN</a:t>
            </a:r>
            <a:r>
              <a:rPr lang="en-US" dirty="0"/>
              <a:t> to form the grid of intermediate-sized rectangles separated by grey/white borders. This grid shows differing Times when expansion ended and Length of expansion. The </a:t>
            </a:r>
            <a:r>
              <a:rPr lang="en-US" dirty="0" smtClean="0"/>
              <a:t>units with a TMRCA &gt; 15,000 years ago are marked with black squar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3605599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0"/>
            <a:ext cx="7315200" cy="6035040"/>
            <a:chOff x="0" y="0"/>
            <a:chExt cx="7315200" cy="6035040"/>
          </a:xfrm>
        </p:grpSpPr>
        <p:pic>
          <p:nvPicPr>
            <p:cNvPr id="1027" name="Picture 3" descr="C:\Users\michael\AppData\Local\Temp\scp45042\nfs\users\nfs_m\ms29\work\DemGraphs\HeatMapR1b5.png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7315200" cy="60350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5400000">
              <a:off x="5922914" y="1458874"/>
              <a:ext cx="23070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Lucida Sans" pitchFamily="34" charset="0"/>
                  <a:cs typeface="Aharoni" pitchFamily="2" charset="-79"/>
                </a:rPr>
                <a:t>Length of Expansion in Years</a:t>
              </a:r>
              <a:endParaRPr lang="en-US" sz="1100" b="1" dirty="0">
                <a:latin typeface="Lucida Sans" pitchFamily="34" charset="0"/>
                <a:cs typeface="Aharoni" pitchFamily="2" charset="-79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7029274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57200"/>
            <a:ext cx="77724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/>
              <a:t>5</a:t>
            </a:r>
            <a:r>
              <a:rPr lang="en-US" b="1" dirty="0" smtClean="0"/>
              <a:t>. </a:t>
            </a:r>
            <a:r>
              <a:rPr lang="en-US" b="1" dirty="0"/>
              <a:t>Fit between model and observed </a:t>
            </a:r>
            <a:r>
              <a:rPr lang="en-US" b="1" dirty="0" smtClean="0"/>
              <a:t>data – R1b</a:t>
            </a:r>
            <a:r>
              <a:rPr lang="en-US" dirty="0" smtClean="0"/>
              <a:t>. </a:t>
            </a:r>
            <a:r>
              <a:rPr lang="en-US" dirty="0"/>
              <a:t>The color of each of the smallest rectangular units indicates the value of AND measuring the fit between the model and the observed tree: red = good fit, yellow and green = intermediate fit, blue = poor fit. Each is based on 1,000 simulations. These small units are assembled into sets with differing values of </a:t>
            </a:r>
            <a:r>
              <a:rPr lang="en-US" dirty="0" err="1"/>
              <a:t>StartN</a:t>
            </a:r>
            <a:r>
              <a:rPr lang="en-US" dirty="0"/>
              <a:t> and </a:t>
            </a:r>
            <a:r>
              <a:rPr lang="en-US" dirty="0" err="1"/>
              <a:t>EndN</a:t>
            </a:r>
            <a:r>
              <a:rPr lang="en-US" dirty="0"/>
              <a:t> to form the grid of intermediate-sized rectangles separated by grey/white borders. This grid shows differing Times when expansion ended and Length of expansion. The </a:t>
            </a:r>
            <a:r>
              <a:rPr lang="en-US" dirty="0" smtClean="0"/>
              <a:t>units with a TMRCA &gt; 15,000 years ago are marked with black squar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8793184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0"/>
            <a:ext cx="7315200" cy="6035040"/>
            <a:chOff x="0" y="0"/>
            <a:chExt cx="7315200" cy="6035040"/>
          </a:xfrm>
        </p:grpSpPr>
        <p:pic>
          <p:nvPicPr>
            <p:cNvPr id="2051" name="Picture 3" descr="C:\Users\michael\AppData\Local\Temp\scp45294\nfs\users\nfs_m\ms29\work\DemGraphs\HeatMapR1b6.png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7315200" cy="60350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5400000">
              <a:off x="5911484" y="1458874"/>
              <a:ext cx="23070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Lucida Sans" pitchFamily="34" charset="0"/>
                  <a:cs typeface="Aharoni" pitchFamily="2" charset="-79"/>
                </a:rPr>
                <a:t>Length of Expansion in Years</a:t>
              </a:r>
              <a:endParaRPr lang="en-US" sz="1100" b="1" dirty="0">
                <a:latin typeface="Lucida Sans" pitchFamily="34" charset="0"/>
                <a:cs typeface="Aharoni" pitchFamily="2" charset="-79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5653062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57200"/>
            <a:ext cx="77724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/>
              <a:t>6</a:t>
            </a:r>
            <a:r>
              <a:rPr lang="en-US" b="1" dirty="0" smtClean="0"/>
              <a:t>. </a:t>
            </a:r>
            <a:r>
              <a:rPr lang="en-US" b="1" dirty="0"/>
              <a:t>Fit between model and observed </a:t>
            </a:r>
            <a:r>
              <a:rPr lang="en-US" b="1" dirty="0" smtClean="0"/>
              <a:t>data – R1b</a:t>
            </a:r>
            <a:r>
              <a:rPr lang="en-US" dirty="0" smtClean="0"/>
              <a:t>. </a:t>
            </a:r>
            <a:r>
              <a:rPr lang="en-US" dirty="0"/>
              <a:t>The color of each of the smallest rectangular units indicates the value of AND measuring the fit between the model and the observed tree: red = good fit, yellow and green = intermediate fit, blue = poor fit. Each is based on 1,000 simulations. These small units are assembled into sets with differing values of </a:t>
            </a:r>
            <a:r>
              <a:rPr lang="en-US" dirty="0" err="1"/>
              <a:t>StartN</a:t>
            </a:r>
            <a:r>
              <a:rPr lang="en-US" dirty="0"/>
              <a:t> and </a:t>
            </a:r>
            <a:r>
              <a:rPr lang="en-US" dirty="0" err="1"/>
              <a:t>EndN</a:t>
            </a:r>
            <a:r>
              <a:rPr lang="en-US" dirty="0"/>
              <a:t> to form the grid of intermediate-sized rectangles separated by grey/white borders. This grid shows differing Times when expansion ended and Length of expansion. The </a:t>
            </a:r>
            <a:r>
              <a:rPr lang="en-US" dirty="0" smtClean="0"/>
              <a:t>units with a TMRCA &gt; 15,000 years ago are marked with black squar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6999234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0"/>
            <a:ext cx="7315200" cy="6035040"/>
            <a:chOff x="0" y="0"/>
            <a:chExt cx="7315200" cy="6035040"/>
          </a:xfrm>
        </p:grpSpPr>
        <p:pic>
          <p:nvPicPr>
            <p:cNvPr id="13315" name="Picture 3" descr="C:\Users\michael\AppData\Local\Temp\scp35056\nfs\users\nfs_m\ms29\work\DemGraphs\HeatMapR1b7.png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7315200" cy="60350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5400000">
              <a:off x="5833106" y="1403716"/>
              <a:ext cx="23070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Lucida Sans" pitchFamily="34" charset="0"/>
                  <a:cs typeface="Aharoni" pitchFamily="2" charset="-79"/>
                </a:rPr>
                <a:t>Length of Expansion in Years</a:t>
              </a:r>
              <a:endParaRPr lang="en-US" sz="1100" b="1" dirty="0">
                <a:latin typeface="Lucida Sans" pitchFamily="34" charset="0"/>
                <a:cs typeface="Aharoni" pitchFamily="2" charset="-79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80161334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57200"/>
            <a:ext cx="77724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/>
              <a:t>7</a:t>
            </a:r>
            <a:r>
              <a:rPr lang="en-US" b="1" dirty="0" smtClean="0"/>
              <a:t>. </a:t>
            </a:r>
            <a:r>
              <a:rPr lang="en-US" b="1" dirty="0"/>
              <a:t>Fit between model and observed </a:t>
            </a:r>
            <a:r>
              <a:rPr lang="en-US" b="1" dirty="0" smtClean="0"/>
              <a:t>data – R1b</a:t>
            </a:r>
            <a:r>
              <a:rPr lang="en-US" dirty="0" smtClean="0"/>
              <a:t>. </a:t>
            </a:r>
            <a:r>
              <a:rPr lang="en-US" dirty="0"/>
              <a:t>The color of each of the smallest rectangular units indicates the value of AND measuring the fit between the model and the observed tree: red = good fit, yellow and green = intermediate fit, blue = poor fit. Each is based on 1,000 simulations. These small units are assembled into sets with differing values of </a:t>
            </a:r>
            <a:r>
              <a:rPr lang="en-US" dirty="0" err="1"/>
              <a:t>StartN</a:t>
            </a:r>
            <a:r>
              <a:rPr lang="en-US" dirty="0"/>
              <a:t> and </a:t>
            </a:r>
            <a:r>
              <a:rPr lang="en-US" dirty="0" err="1"/>
              <a:t>EndN</a:t>
            </a:r>
            <a:r>
              <a:rPr lang="en-US" dirty="0"/>
              <a:t> to form the grid of intermediate-sized rectangles separated by grey/white borders. This grid shows differing Times when expansion ended and Length of expansion. The </a:t>
            </a:r>
            <a:r>
              <a:rPr lang="en-US" dirty="0" smtClean="0"/>
              <a:t>units with a TMRCA &gt; 15,000 years ago are marked with black squar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25922948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0"/>
            <a:ext cx="7315200" cy="6035040"/>
            <a:chOff x="0" y="0"/>
            <a:chExt cx="7315200" cy="6035040"/>
          </a:xfrm>
        </p:grpSpPr>
        <p:pic>
          <p:nvPicPr>
            <p:cNvPr id="14338" name="Picture 2" descr="C:\Users\michael\AppData\Local\Temp\scp35862\nfs\users\nfs_m\ms29\work\DemGraphs\HeatMapR1b9.png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7315200" cy="60350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5400000">
              <a:off x="5824046" y="1458874"/>
              <a:ext cx="23070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Lucida Sans" pitchFamily="34" charset="0"/>
                  <a:cs typeface="Aharoni" pitchFamily="2" charset="-79"/>
                </a:rPr>
                <a:t>Length of Expansion in Years</a:t>
              </a:r>
              <a:endParaRPr lang="en-US" sz="1100" b="1" dirty="0">
                <a:latin typeface="Lucida Sans" pitchFamily="34" charset="0"/>
                <a:cs typeface="Aharoni" pitchFamily="2" charset="-79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9499526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57200"/>
            <a:ext cx="77724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8. </a:t>
            </a:r>
            <a:r>
              <a:rPr lang="en-US" b="1" dirty="0"/>
              <a:t>Fit between model and observed </a:t>
            </a:r>
            <a:r>
              <a:rPr lang="en-US" b="1" dirty="0" smtClean="0"/>
              <a:t>data – R1b</a:t>
            </a:r>
            <a:r>
              <a:rPr lang="en-US" dirty="0" smtClean="0"/>
              <a:t>. </a:t>
            </a:r>
            <a:r>
              <a:rPr lang="en-US" dirty="0"/>
              <a:t>The color of each of the smallest rectangular units indicates the value of AND measuring the fit between the model and the observed tree: red = good fit, yellow and green = intermediate fit, blue = poor fit. Each is based on 1,000 simulations. These small units are assembled into sets with differing values of </a:t>
            </a:r>
            <a:r>
              <a:rPr lang="en-US" dirty="0" err="1"/>
              <a:t>StartN</a:t>
            </a:r>
            <a:r>
              <a:rPr lang="en-US" dirty="0"/>
              <a:t> and </a:t>
            </a:r>
            <a:r>
              <a:rPr lang="en-US" dirty="0" err="1"/>
              <a:t>EndN</a:t>
            </a:r>
            <a:r>
              <a:rPr lang="en-US" dirty="0"/>
              <a:t> to form the grid of intermediate-sized rectangles separated by grey/white borders. This grid shows differing Times when expansion ended and Length of expansion. The </a:t>
            </a:r>
            <a:r>
              <a:rPr lang="en-US" dirty="0" smtClean="0"/>
              <a:t>units with a TMRCA &gt; 15,000 years ago are marked with black squar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745695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7315200" cy="6035040"/>
            <a:chOff x="0" y="0"/>
            <a:chExt cx="7315200" cy="6035040"/>
          </a:xfrm>
        </p:grpSpPr>
        <p:pic>
          <p:nvPicPr>
            <p:cNvPr id="8194" name="Picture 2" descr="C:\Users\michael\AppData\Local\Temp\scp29385\nfs\users\nfs_m\ms29\work\DemGraphs\HeatMapBantu1.png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7315200" cy="60350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 rot="5400000">
              <a:off x="5846714" y="1448532"/>
              <a:ext cx="23070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Lucida Sans" pitchFamily="34" charset="0"/>
                  <a:cs typeface="Aharoni" pitchFamily="2" charset="-79"/>
                </a:rPr>
                <a:t>Length of Expansion in Years</a:t>
              </a:r>
              <a:endParaRPr lang="en-US" sz="1100" b="1" dirty="0">
                <a:latin typeface="Lucida Sans" pitchFamily="34" charset="0"/>
                <a:cs typeface="Aharoni" pitchFamily="2" charset="-79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733222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57200"/>
            <a:ext cx="77724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/>
              <a:t>2</a:t>
            </a:r>
            <a:r>
              <a:rPr lang="en-US" b="1" dirty="0" smtClean="0"/>
              <a:t>. </a:t>
            </a:r>
            <a:r>
              <a:rPr lang="en-US" b="1" dirty="0"/>
              <a:t>Fit between model and observed </a:t>
            </a:r>
            <a:r>
              <a:rPr lang="en-US" b="1" dirty="0" smtClean="0"/>
              <a:t>data – E1b1a</a:t>
            </a:r>
            <a:r>
              <a:rPr lang="en-US" dirty="0" smtClean="0"/>
              <a:t>. </a:t>
            </a:r>
            <a:r>
              <a:rPr lang="en-US" dirty="0"/>
              <a:t>The color of each of the smallest rectangular units indicates the value of AND measuring the fit between the model and the observed tree: red = good fit, yellow and green = intermediate fit, blue = poor fit. Each is based on 1,000 simulations. These small units are assembled into sets with differing values of </a:t>
            </a:r>
            <a:r>
              <a:rPr lang="en-US" dirty="0" err="1"/>
              <a:t>StartN</a:t>
            </a:r>
            <a:r>
              <a:rPr lang="en-US" dirty="0"/>
              <a:t> and </a:t>
            </a:r>
            <a:r>
              <a:rPr lang="en-US" dirty="0" err="1"/>
              <a:t>EndN</a:t>
            </a:r>
            <a:r>
              <a:rPr lang="en-US" dirty="0"/>
              <a:t> to form the grid of intermediate-sized rectangles separated by grey/white borders. This grid shows differing Times when expansion ended and Length of expansion. The </a:t>
            </a:r>
            <a:r>
              <a:rPr lang="en-US" dirty="0" smtClean="0"/>
              <a:t>units with a TMRCA &gt; 20,000 years ago are marked with black squar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55058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0"/>
            <a:ext cx="7315200" cy="6035040"/>
            <a:chOff x="0" y="0"/>
            <a:chExt cx="7315200" cy="6035040"/>
          </a:xfrm>
        </p:grpSpPr>
        <p:pic>
          <p:nvPicPr>
            <p:cNvPr id="9218" name="Picture 2" descr="C:\Users\michael\AppData\Local\Temp\scp29984\nfs\users\nfs_m\ms29\work\DemGraphs\HeatMapBantu7.png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7315200" cy="60350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5400000">
              <a:off x="5987684" y="1437102"/>
              <a:ext cx="23070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Lucida Sans" pitchFamily="34" charset="0"/>
                  <a:cs typeface="Aharoni" pitchFamily="2" charset="-79"/>
                </a:rPr>
                <a:t>Length of Expansion in Years</a:t>
              </a:r>
              <a:endParaRPr lang="en-US" sz="1100" b="1" dirty="0">
                <a:latin typeface="Lucida Sans" pitchFamily="34" charset="0"/>
                <a:cs typeface="Aharoni" pitchFamily="2" charset="-79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887889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57200"/>
            <a:ext cx="77724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/>
              <a:t>3</a:t>
            </a:r>
            <a:r>
              <a:rPr lang="en-US" b="1" dirty="0" smtClean="0"/>
              <a:t>. </a:t>
            </a:r>
            <a:r>
              <a:rPr lang="en-US" b="1" dirty="0"/>
              <a:t>Fit between model and observed </a:t>
            </a:r>
            <a:r>
              <a:rPr lang="en-US" b="1" dirty="0" smtClean="0"/>
              <a:t>data – E1b1a</a:t>
            </a:r>
            <a:r>
              <a:rPr lang="en-US" dirty="0" smtClean="0"/>
              <a:t>. </a:t>
            </a:r>
            <a:r>
              <a:rPr lang="en-US" dirty="0"/>
              <a:t>The color of each of the smallest rectangular units indicates the value of AND measuring the fit between the model and the observed tree: red = good fit, yellow and green = intermediate fit, blue = poor fit. Each is based on 1,000 simulations. These small units are assembled into sets with differing values of </a:t>
            </a:r>
            <a:r>
              <a:rPr lang="en-US" dirty="0" err="1"/>
              <a:t>StartN</a:t>
            </a:r>
            <a:r>
              <a:rPr lang="en-US" dirty="0"/>
              <a:t> and </a:t>
            </a:r>
            <a:r>
              <a:rPr lang="en-US" dirty="0" err="1"/>
              <a:t>EndN</a:t>
            </a:r>
            <a:r>
              <a:rPr lang="en-US" dirty="0"/>
              <a:t> to form the grid of intermediate-sized rectangles separated by grey/white borders. This grid shows differing Times when expansion ended and Length of expansion. The </a:t>
            </a:r>
            <a:r>
              <a:rPr lang="en-US" dirty="0" smtClean="0"/>
              <a:t>units with a TMRCA &gt; 20,000 years ago are marked with black squar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04257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1430" y="0"/>
            <a:ext cx="7315200" cy="6035040"/>
            <a:chOff x="11430" y="0"/>
            <a:chExt cx="7315200" cy="6035040"/>
          </a:xfrm>
        </p:grpSpPr>
        <p:pic>
          <p:nvPicPr>
            <p:cNvPr id="3" name="Picture 2" descr="C:\Users\michael\AppData\Local\Temp\scp29687\nfs\users\nfs_m\ms29\work\DemGraphs\HeatMapBantu5.png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430" y="0"/>
              <a:ext cx="7315200" cy="60350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5400000">
              <a:off x="5911484" y="1437102"/>
              <a:ext cx="23070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Lucida Sans" pitchFamily="34" charset="0"/>
                  <a:cs typeface="Aharoni" pitchFamily="2" charset="-79"/>
                </a:rPr>
                <a:t>Length of Expansion in Years</a:t>
              </a:r>
              <a:endParaRPr lang="en-US" sz="1100" b="1" dirty="0">
                <a:latin typeface="Lucida Sans" pitchFamily="34" charset="0"/>
                <a:cs typeface="Aharoni" pitchFamily="2" charset="-79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027988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57200"/>
            <a:ext cx="77724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</a:t>
            </a:r>
            <a:r>
              <a:rPr lang="en-US" b="1" dirty="0"/>
              <a:t>4</a:t>
            </a:r>
            <a:r>
              <a:rPr lang="en-US" b="1" dirty="0" smtClean="0"/>
              <a:t>. </a:t>
            </a:r>
            <a:r>
              <a:rPr lang="en-US" b="1" dirty="0"/>
              <a:t>Fit between model and observed </a:t>
            </a:r>
            <a:r>
              <a:rPr lang="en-US" b="1" dirty="0" smtClean="0"/>
              <a:t>data – E1b1a</a:t>
            </a:r>
            <a:r>
              <a:rPr lang="en-US" dirty="0" smtClean="0"/>
              <a:t>. </a:t>
            </a:r>
            <a:r>
              <a:rPr lang="en-US" dirty="0"/>
              <a:t>The color of each of the smallest rectangular units indicates the value of AND measuring the fit between the model and the observed tree: red = good fit, yellow and green = intermediate fit, blue = poor fit. Each is based on 1,000 simulations. These small units are assembled into sets with differing values of </a:t>
            </a:r>
            <a:r>
              <a:rPr lang="en-US" dirty="0" err="1"/>
              <a:t>StartN</a:t>
            </a:r>
            <a:r>
              <a:rPr lang="en-US" dirty="0"/>
              <a:t> and </a:t>
            </a:r>
            <a:r>
              <a:rPr lang="en-US" dirty="0" err="1"/>
              <a:t>EndN</a:t>
            </a:r>
            <a:r>
              <a:rPr lang="en-US" dirty="0"/>
              <a:t> to form the grid of intermediate-sized rectangles separated by grey/white borders. This grid shows differing Times when expansion ended and Length of expansion. The </a:t>
            </a:r>
            <a:r>
              <a:rPr lang="en-US" dirty="0" smtClean="0"/>
              <a:t>units with a TMRCA &gt; 20,000 years ago are marked with black square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409730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0"/>
            <a:ext cx="7315200" cy="6035040"/>
            <a:chOff x="0" y="0"/>
            <a:chExt cx="7315200" cy="6035040"/>
          </a:xfrm>
        </p:grpSpPr>
        <p:pic>
          <p:nvPicPr>
            <p:cNvPr id="10242" name="Picture 2" descr="C:\Users\michael\AppData\Local\Temp\scp30580\nfs\users\nfs_m\ms29\work\DemGraphs\HeatMapBantu2.png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7315200" cy="60350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5400000">
              <a:off x="5911484" y="1437102"/>
              <a:ext cx="23070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Lucida Sans" pitchFamily="34" charset="0"/>
                  <a:cs typeface="Aharoni" pitchFamily="2" charset="-79"/>
                </a:rPr>
                <a:t>Length of Expansion in Years</a:t>
              </a:r>
              <a:endParaRPr lang="en-US" sz="1100" b="1" dirty="0">
                <a:latin typeface="Lucida Sans" pitchFamily="34" charset="0"/>
                <a:cs typeface="Aharoni" pitchFamily="2" charset="-79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684130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9</TotalTime>
  <Words>1694</Words>
  <Application>Microsoft Office PowerPoint</Application>
  <PresentationFormat>On-screen Show (4:3)</PresentationFormat>
  <Paragraphs>28</Paragraphs>
  <Slides>2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9</vt:i4>
      </vt:variant>
    </vt:vector>
  </HeadingPairs>
  <TitlesOfParts>
    <vt:vector size="30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</dc:creator>
  <cp:lastModifiedBy>Chris Tyler-Smith</cp:lastModifiedBy>
  <cp:revision>28</cp:revision>
  <dcterms:created xsi:type="dcterms:W3CDTF">2013-08-13T03:07:59Z</dcterms:created>
  <dcterms:modified xsi:type="dcterms:W3CDTF">2013-10-15T15:53:06Z</dcterms:modified>
</cp:coreProperties>
</file>